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-72" y="28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109195-92C3-4589-90F3-F32DB81470F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176C42-8C97-4A8E-A7DC-3E0BB1FAF0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8367731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833275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16234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957991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109559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741227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859833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048084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631156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131412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265278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209387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1E1AF7-A4DB-431F-8AC4-A189BB30EF62}" type="datetimeFigureOut">
              <a:rPr lang="en-GB" smtClean="0"/>
              <a:pPr/>
              <a:t>16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CE10E0-DE01-4806-9F36-8D191B19BD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854659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586696" y="218087"/>
            <a:ext cx="5488256" cy="8010720"/>
            <a:chOff x="586696" y="218087"/>
            <a:chExt cx="5488256" cy="8010720"/>
          </a:xfrm>
        </p:grpSpPr>
        <p:grpSp>
          <p:nvGrpSpPr>
            <p:cNvPr id="11" name="Group 10"/>
            <p:cNvGrpSpPr/>
            <p:nvPr/>
          </p:nvGrpSpPr>
          <p:grpSpPr>
            <a:xfrm>
              <a:off x="586696" y="954009"/>
              <a:ext cx="5488256" cy="6592451"/>
              <a:chOff x="586696" y="1174733"/>
              <a:chExt cx="5488256" cy="6592451"/>
            </a:xfrm>
          </p:grpSpPr>
          <p:pic>
            <p:nvPicPr>
              <p:cNvPr id="5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6696" y="1382769"/>
                <a:ext cx="2560637" cy="192012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14315" y="1382770"/>
                <a:ext cx="2560637" cy="192012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" name="Picture 4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6697" y="3626725"/>
                <a:ext cx="2560637" cy="192012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8" name="Picture 5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14315" y="3626726"/>
                <a:ext cx="2560637" cy="192012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" name="Picture 6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6697" y="5847061"/>
                <a:ext cx="2560637" cy="192012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" name="Picture 7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14315" y="5847061"/>
                <a:ext cx="2560637" cy="192012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702660" y="1174733"/>
                <a:ext cx="25840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/>
                  <a:t>a</a:t>
                </a:r>
                <a:endParaRPr lang="en-GB" sz="1200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606121" y="1174733"/>
                <a:ext cx="2648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b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710674" y="3416402"/>
                <a:ext cx="25039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c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3606121" y="3450126"/>
                <a:ext cx="2648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/>
                  <a:t>d</a:t>
                </a:r>
                <a:endParaRPr lang="en-GB" sz="1200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701149" y="5679986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e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630258" y="5673619"/>
                <a:ext cx="2311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f</a:t>
                </a:r>
              </a:p>
            </p:txBody>
          </p:sp>
        </p:grpSp>
        <p:sp>
          <p:nvSpPr>
            <p:cNvPr id="17" name="TextBox 16"/>
            <p:cNvSpPr txBox="1"/>
            <p:nvPr/>
          </p:nvSpPr>
          <p:spPr>
            <a:xfrm>
              <a:off x="2645197" y="218087"/>
              <a:ext cx="17382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Supplementary Figure S1</a:t>
              </a:r>
              <a:endParaRPr lang="en-GB" sz="12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86696" y="7767142"/>
              <a:ext cx="514100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1200" dirty="0" smtClean="0"/>
                <a:t>Supplementary Figure S1: Sequencing saturation curves D0 (a), Pr-Fl-PLLA (b), Pr-Fs-PLLA (c), Am-Fl-PLLA (d), Am-Fs-PLLA (e), and TCP (f).   </a:t>
              </a:r>
              <a:endParaRPr lang="en-GB" sz="1200" dirty="0"/>
            </a:p>
          </p:txBody>
        </p:sp>
      </p:grpSp>
    </p:spTree>
    <p:extLst>
      <p:ext uri="{BB962C8B-B14F-4D97-AF65-F5344CB8AC3E}">
        <p14:creationId xmlns="" xmlns:p14="http://schemas.microsoft.com/office/powerpoint/2010/main" val="3955024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41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Dept of Zoology, University of Oxfo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i Wang</dc:creator>
  <cp:lastModifiedBy>Naresh Kasoju</cp:lastModifiedBy>
  <cp:revision>5</cp:revision>
  <dcterms:created xsi:type="dcterms:W3CDTF">2017-07-06T20:29:44Z</dcterms:created>
  <dcterms:modified xsi:type="dcterms:W3CDTF">2018-07-16T06:09:02Z</dcterms:modified>
</cp:coreProperties>
</file>